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64">
          <p15:clr>
            <a:srgbClr val="A4A3A4"/>
          </p15:clr>
        </p15:guide>
        <p15:guide id="2" pos="258">
          <p15:clr>
            <a:srgbClr val="A4A3A4"/>
          </p15:clr>
        </p15:guide>
        <p15:guide id="3" orient="horz" pos="382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5" autoAdjust="0"/>
    <p:restoredTop sz="94660"/>
  </p:normalViewPr>
  <p:slideViewPr>
    <p:cSldViewPr snapToGrid="0">
      <p:cViewPr varScale="1">
        <p:scale>
          <a:sx n="61" d="100"/>
          <a:sy n="61" d="100"/>
        </p:scale>
        <p:origin x="2400" y="62"/>
      </p:cViewPr>
      <p:guideLst>
        <p:guide orient="horz" pos="4864"/>
        <p:guide pos="258"/>
        <p:guide orient="horz" pos="382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unka\MBK\Zula\Leaf%20graph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unka\MBK\Zula\Leaf%20graph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 sz="1800" b="1"/>
              <a:t>HP</a:t>
            </a:r>
            <a:r>
              <a:rPr lang="hu-HU" sz="1800" b="1" baseline="0"/>
              <a:t> leaf</a:t>
            </a:r>
            <a:endParaRPr lang="hu-HU" sz="1800" b="1"/>
          </a:p>
        </c:rich>
      </c:tx>
      <c:layout>
        <c:manualLayout>
          <c:xMode val="edge"/>
          <c:yMode val="edge"/>
          <c:x val="0.44539807524059499"/>
          <c:y val="4.4491530990365721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2!$G$3:$G$33</c:f>
                <c:numCache>
                  <c:formatCode>General</c:formatCode>
                  <c:ptCount val="31"/>
                  <c:pt idx="0">
                    <c:v>5.7948815485064739E-2</c:v>
                  </c:pt>
                  <c:pt idx="1">
                    <c:v>5.0569454652413994E-3</c:v>
                  </c:pt>
                  <c:pt idx="2">
                    <c:v>2.0865254578971792</c:v>
                  </c:pt>
                  <c:pt idx="3">
                    <c:v>5.1351386957652234E-2</c:v>
                  </c:pt>
                  <c:pt idx="4">
                    <c:v>3.86109836493244E-3</c:v>
                  </c:pt>
                  <c:pt idx="5">
                    <c:v>1.8323514073141031E-2</c:v>
                  </c:pt>
                  <c:pt idx="6">
                    <c:v>7.8516833389180987E-2</c:v>
                  </c:pt>
                  <c:pt idx="7">
                    <c:v>0.28179061516579734</c:v>
                  </c:pt>
                  <c:pt idx="8">
                    <c:v>0.23759876842899741</c:v>
                  </c:pt>
                  <c:pt idx="9">
                    <c:v>4.6049537172950855E-3</c:v>
                  </c:pt>
                  <c:pt idx="10">
                    <c:v>1.0232781882948605E-2</c:v>
                  </c:pt>
                  <c:pt idx="11">
                    <c:v>0.48008425137612032</c:v>
                  </c:pt>
                  <c:pt idx="12">
                    <c:v>1.7178549949933303E-2</c:v>
                  </c:pt>
                  <c:pt idx="13">
                    <c:v>2.4409589560069282E-2</c:v>
                  </c:pt>
                  <c:pt idx="14">
                    <c:v>4.5613791023626934E-2</c:v>
                  </c:pt>
                  <c:pt idx="15">
                    <c:v>2.7721704519363799</c:v>
                  </c:pt>
                  <c:pt idx="16">
                    <c:v>7.7185837993722032E-3</c:v>
                  </c:pt>
                  <c:pt idx="17">
                    <c:v>2.0962954696457032</c:v>
                  </c:pt>
                  <c:pt idx="18">
                    <c:v>6.0980996159906136</c:v>
                  </c:pt>
                  <c:pt idx="19">
                    <c:v>0.16177444642450406</c:v>
                  </c:pt>
                  <c:pt idx="20">
                    <c:v>0.38231113926302374</c:v>
                  </c:pt>
                  <c:pt idx="21">
                    <c:v>6.8532191876783822E-3</c:v>
                  </c:pt>
                  <c:pt idx="22">
                    <c:v>13.979530801322905</c:v>
                  </c:pt>
                  <c:pt idx="23">
                    <c:v>6.8235303339614283E-3</c:v>
                  </c:pt>
                  <c:pt idx="24">
                    <c:v>2.1293732222578412</c:v>
                  </c:pt>
                  <c:pt idx="25">
                    <c:v>1.7793227063107049E-2</c:v>
                  </c:pt>
                  <c:pt idx="26">
                    <c:v>7.4543525370043421E-3</c:v>
                  </c:pt>
                  <c:pt idx="27">
                    <c:v>7.8338822482758291E-3</c:v>
                  </c:pt>
                  <c:pt idx="28">
                    <c:v>2.3607232546378969E-2</c:v>
                  </c:pt>
                  <c:pt idx="29">
                    <c:v>9.1960338589175267E-3</c:v>
                  </c:pt>
                  <c:pt idx="30">
                    <c:v>1.72364877668967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2!$B$3:$B$33</c:f>
              <c:strCache>
                <c:ptCount val="31"/>
                <c:pt idx="0">
                  <c:v>Valine </c:v>
                </c:pt>
                <c:pt idx="1">
                  <c:v>Isoleucine</c:v>
                </c:pt>
                <c:pt idx="2">
                  <c:v>Proline</c:v>
                </c:pt>
                <c:pt idx="3">
                  <c:v>Glycine</c:v>
                </c:pt>
                <c:pt idx="4">
                  <c:v>Serine </c:v>
                </c:pt>
                <c:pt idx="5">
                  <c:v>L-Threonine</c:v>
                </c:pt>
                <c:pt idx="6">
                  <c:v>B-alanine</c:v>
                </c:pt>
                <c:pt idx="7">
                  <c:v>L-Aspartic-acid</c:v>
                </c:pt>
                <c:pt idx="8">
                  <c:v>5-oxo-Proline</c:v>
                </c:pt>
                <c:pt idx="9">
                  <c:v>GABA </c:v>
                </c:pt>
                <c:pt idx="10">
                  <c:v>Ornithine</c:v>
                </c:pt>
                <c:pt idx="11">
                  <c:v>Glutamic acid</c:v>
                </c:pt>
                <c:pt idx="12">
                  <c:v>Phenylalanine</c:v>
                </c:pt>
                <c:pt idx="13">
                  <c:v>L-Asparagine</c:v>
                </c:pt>
                <c:pt idx="14">
                  <c:v>L-Tryptophan</c:v>
                </c:pt>
                <c:pt idx="15">
                  <c:v>Fructose</c:v>
                </c:pt>
                <c:pt idx="16">
                  <c:v>Galactose</c:v>
                </c:pt>
                <c:pt idx="17">
                  <c:v>Glucose</c:v>
                </c:pt>
                <c:pt idx="18">
                  <c:v>Sucrose</c:v>
                </c:pt>
                <c:pt idx="19">
                  <c:v>Mannitol</c:v>
                </c:pt>
                <c:pt idx="20">
                  <c:v>Myo-inositol</c:v>
                </c:pt>
                <c:pt idx="21">
                  <c:v>Galactinol </c:v>
                </c:pt>
                <c:pt idx="22">
                  <c:v>Malic acid</c:v>
                </c:pt>
                <c:pt idx="23">
                  <c:v>Pentonic acid</c:v>
                </c:pt>
                <c:pt idx="24">
                  <c:v>Citric acid</c:v>
                </c:pt>
                <c:pt idx="25">
                  <c:v>Palmitic acid</c:v>
                </c:pt>
                <c:pt idx="26">
                  <c:v>Galactaric acid</c:v>
                </c:pt>
                <c:pt idx="27">
                  <c:v>Arabino-hexaric a.</c:v>
                </c:pt>
                <c:pt idx="28">
                  <c:v>Stearic acid</c:v>
                </c:pt>
                <c:pt idx="29">
                  <c:v>Glucuronic acid </c:v>
                </c:pt>
                <c:pt idx="30">
                  <c:v>Phosphoric acid</c:v>
                </c:pt>
              </c:strCache>
            </c:strRef>
          </c:cat>
          <c:val>
            <c:numRef>
              <c:f>Munka2!$F$3:$F$33</c:f>
              <c:numCache>
                <c:formatCode>General</c:formatCode>
                <c:ptCount val="31"/>
                <c:pt idx="0">
                  <c:v>8.376326374068177E-2</c:v>
                </c:pt>
                <c:pt idx="1">
                  <c:v>1.7407006947618545E-2</c:v>
                </c:pt>
                <c:pt idx="2">
                  <c:v>2.4232881905487207</c:v>
                </c:pt>
                <c:pt idx="3">
                  <c:v>0.24102663457165621</c:v>
                </c:pt>
                <c:pt idx="4">
                  <c:v>0.31525195422980201</c:v>
                </c:pt>
                <c:pt idx="5">
                  <c:v>0.14669579845129924</c:v>
                </c:pt>
                <c:pt idx="6">
                  <c:v>7.1513705771919886E-2</c:v>
                </c:pt>
                <c:pt idx="7">
                  <c:v>0.66376542776963765</c:v>
                </c:pt>
                <c:pt idx="8">
                  <c:v>0.52706558428003958</c:v>
                </c:pt>
                <c:pt idx="9">
                  <c:v>3.2350333845794006E-2</c:v>
                </c:pt>
                <c:pt idx="10">
                  <c:v>1.4109516201296524E-2</c:v>
                </c:pt>
                <c:pt idx="11">
                  <c:v>0.49929253575651078</c:v>
                </c:pt>
                <c:pt idx="12">
                  <c:v>3.4497844531011582E-2</c:v>
                </c:pt>
                <c:pt idx="13">
                  <c:v>4.2639844863879686E-2</c:v>
                </c:pt>
                <c:pt idx="14">
                  <c:v>7.6130726738520019E-2</c:v>
                </c:pt>
                <c:pt idx="15">
                  <c:v>11.305100771570546</c:v>
                </c:pt>
                <c:pt idx="16">
                  <c:v>2.2728912000000011E-2</c:v>
                </c:pt>
                <c:pt idx="17">
                  <c:v>8.7704031079513207</c:v>
                </c:pt>
                <c:pt idx="18">
                  <c:v>19.065533893864359</c:v>
                </c:pt>
                <c:pt idx="19">
                  <c:v>0.22043300887285572</c:v>
                </c:pt>
                <c:pt idx="20">
                  <c:v>0.8061114035139566</c:v>
                </c:pt>
                <c:pt idx="21">
                  <c:v>2.3719199810217657E-2</c:v>
                </c:pt>
                <c:pt idx="22">
                  <c:v>19.21290061929222</c:v>
                </c:pt>
                <c:pt idx="23">
                  <c:v>2.9354418432996517E-2</c:v>
                </c:pt>
                <c:pt idx="24">
                  <c:v>2.4976539728011677</c:v>
                </c:pt>
                <c:pt idx="25">
                  <c:v>0.25874503411428179</c:v>
                </c:pt>
                <c:pt idx="26">
                  <c:v>2.8246029242000703E-2</c:v>
                </c:pt>
                <c:pt idx="27">
                  <c:v>5.0454238287123816E-2</c:v>
                </c:pt>
                <c:pt idx="28">
                  <c:v>0.28442176118601198</c:v>
                </c:pt>
                <c:pt idx="29">
                  <c:v>6.6793969118534094E-2</c:v>
                </c:pt>
                <c:pt idx="30">
                  <c:v>3.62019035848742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78-415C-9FAB-4C701C2A36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83862880"/>
        <c:axId val="883863424"/>
      </c:barChart>
      <c:catAx>
        <c:axId val="883862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3863424"/>
        <c:crosses val="autoZero"/>
        <c:auto val="1"/>
        <c:lblAlgn val="ctr"/>
        <c:lblOffset val="100"/>
        <c:noMultiLvlLbl val="0"/>
      </c:catAx>
      <c:valAx>
        <c:axId val="8838634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/>
                  <a:t>Relative conte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38628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 sz="1800" b="1"/>
              <a:t>WL</a:t>
            </a:r>
            <a:r>
              <a:rPr lang="hu-HU" sz="1800" b="1" baseline="0"/>
              <a:t> leaf</a:t>
            </a:r>
            <a:endParaRPr lang="hu-HU" sz="1800" b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2!$Q$3:$Q$33</c:f>
                <c:numCache>
                  <c:formatCode>General</c:formatCode>
                  <c:ptCount val="31"/>
                  <c:pt idx="0">
                    <c:v>3.4252518240704403E-2</c:v>
                  </c:pt>
                  <c:pt idx="1">
                    <c:v>1.2931173387510483E-2</c:v>
                  </c:pt>
                  <c:pt idx="2">
                    <c:v>2.2094503923694999</c:v>
                  </c:pt>
                  <c:pt idx="3">
                    <c:v>0.14631479737604441</c:v>
                  </c:pt>
                  <c:pt idx="4">
                    <c:v>0.10156864923014752</c:v>
                  </c:pt>
                  <c:pt idx="5">
                    <c:v>2.6893004633763287E-2</c:v>
                  </c:pt>
                  <c:pt idx="6">
                    <c:v>9.3059259630389524E-2</c:v>
                  </c:pt>
                  <c:pt idx="7">
                    <c:v>0.11473502197272618</c:v>
                  </c:pt>
                  <c:pt idx="8">
                    <c:v>1.231647238203742</c:v>
                  </c:pt>
                  <c:pt idx="9">
                    <c:v>1.8206489336227524E-2</c:v>
                  </c:pt>
                  <c:pt idx="10">
                    <c:v>5.8307260807587778E-3</c:v>
                  </c:pt>
                  <c:pt idx="11">
                    <c:v>0.80470415929668571</c:v>
                  </c:pt>
                  <c:pt idx="12">
                    <c:v>1.9137142710746461E-2</c:v>
                  </c:pt>
                  <c:pt idx="13">
                    <c:v>2.639044965914137E-2</c:v>
                  </c:pt>
                  <c:pt idx="14">
                    <c:v>2.7600414967517899E-2</c:v>
                  </c:pt>
                  <c:pt idx="15">
                    <c:v>1.0448836298787727</c:v>
                  </c:pt>
                  <c:pt idx="16">
                    <c:v>7.9025260529195732E-3</c:v>
                  </c:pt>
                  <c:pt idx="17">
                    <c:v>0.4187902854823598</c:v>
                  </c:pt>
                  <c:pt idx="18">
                    <c:v>3.8185260085234902</c:v>
                  </c:pt>
                  <c:pt idx="19">
                    <c:v>2.0019057133684265E-2</c:v>
                  </c:pt>
                  <c:pt idx="20">
                    <c:v>1.96486338281887E-2</c:v>
                  </c:pt>
                  <c:pt idx="21">
                    <c:v>1.6799412041794446E-2</c:v>
                  </c:pt>
                  <c:pt idx="22">
                    <c:v>18.88169833079408</c:v>
                  </c:pt>
                  <c:pt idx="23">
                    <c:v>2.1314938692658315E-2</c:v>
                  </c:pt>
                  <c:pt idx="24">
                    <c:v>0.28247399499862824</c:v>
                  </c:pt>
                  <c:pt idx="25">
                    <c:v>0.12828754168481105</c:v>
                  </c:pt>
                  <c:pt idx="26">
                    <c:v>1.3209206418158129E-2</c:v>
                  </c:pt>
                  <c:pt idx="27">
                    <c:v>9.9185744078699768E-3</c:v>
                  </c:pt>
                  <c:pt idx="28">
                    <c:v>0.1290098500370595</c:v>
                  </c:pt>
                  <c:pt idx="29">
                    <c:v>5.710912366609576E-2</c:v>
                  </c:pt>
                  <c:pt idx="30">
                    <c:v>4.73102791405401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2!$B$3:$B$33</c:f>
              <c:strCache>
                <c:ptCount val="31"/>
                <c:pt idx="0">
                  <c:v>Valine </c:v>
                </c:pt>
                <c:pt idx="1">
                  <c:v>Isoleucine</c:v>
                </c:pt>
                <c:pt idx="2">
                  <c:v>Proline</c:v>
                </c:pt>
                <c:pt idx="3">
                  <c:v>Glycine</c:v>
                </c:pt>
                <c:pt idx="4">
                  <c:v>Serine </c:v>
                </c:pt>
                <c:pt idx="5">
                  <c:v>L-Threonine</c:v>
                </c:pt>
                <c:pt idx="6">
                  <c:v>B-alanine</c:v>
                </c:pt>
                <c:pt idx="7">
                  <c:v>L-Aspartic-acid</c:v>
                </c:pt>
                <c:pt idx="8">
                  <c:v>5-oxo-Proline</c:v>
                </c:pt>
                <c:pt idx="9">
                  <c:v>GABA </c:v>
                </c:pt>
                <c:pt idx="10">
                  <c:v>Ornithine</c:v>
                </c:pt>
                <c:pt idx="11">
                  <c:v>Glutamic acid</c:v>
                </c:pt>
                <c:pt idx="12">
                  <c:v>Phenylalanine</c:v>
                </c:pt>
                <c:pt idx="13">
                  <c:v>L-Asparagine</c:v>
                </c:pt>
                <c:pt idx="14">
                  <c:v>L-Tryptophan</c:v>
                </c:pt>
                <c:pt idx="15">
                  <c:v>Fructose</c:v>
                </c:pt>
                <c:pt idx="16">
                  <c:v>Galactose</c:v>
                </c:pt>
                <c:pt idx="17">
                  <c:v>Glucose</c:v>
                </c:pt>
                <c:pt idx="18">
                  <c:v>Sucrose</c:v>
                </c:pt>
                <c:pt idx="19">
                  <c:v>Mannitol</c:v>
                </c:pt>
                <c:pt idx="20">
                  <c:v>Myo-inositol</c:v>
                </c:pt>
                <c:pt idx="21">
                  <c:v>Galactinol </c:v>
                </c:pt>
                <c:pt idx="22">
                  <c:v>Malic acid</c:v>
                </c:pt>
                <c:pt idx="23">
                  <c:v>Pentonic acid</c:v>
                </c:pt>
                <c:pt idx="24">
                  <c:v>Citric acid</c:v>
                </c:pt>
                <c:pt idx="25">
                  <c:v>Palmitic acid</c:v>
                </c:pt>
                <c:pt idx="26">
                  <c:v>Galactaric acid</c:v>
                </c:pt>
                <c:pt idx="27">
                  <c:v>Arabino-hexaric a.</c:v>
                </c:pt>
                <c:pt idx="28">
                  <c:v>Stearic acid</c:v>
                </c:pt>
                <c:pt idx="29">
                  <c:v>Glucuronic acid </c:v>
                </c:pt>
                <c:pt idx="30">
                  <c:v>Phosphoric acid</c:v>
                </c:pt>
              </c:strCache>
            </c:strRef>
          </c:cat>
          <c:val>
            <c:numRef>
              <c:f>Munka2!$P$3:$P$33</c:f>
              <c:numCache>
                <c:formatCode>General</c:formatCode>
                <c:ptCount val="31"/>
                <c:pt idx="0">
                  <c:v>8.4199405868446861E-2</c:v>
                </c:pt>
                <c:pt idx="1">
                  <c:v>2.2549849471061055E-2</c:v>
                </c:pt>
                <c:pt idx="2">
                  <c:v>1.3779742808852715</c:v>
                </c:pt>
                <c:pt idx="3">
                  <c:v>0.2936531266900082</c:v>
                </c:pt>
                <c:pt idx="4">
                  <c:v>0.41230885167942988</c:v>
                </c:pt>
                <c:pt idx="5">
                  <c:v>0.12744242912085621</c:v>
                </c:pt>
                <c:pt idx="6">
                  <c:v>7.1488049475385201E-2</c:v>
                </c:pt>
                <c:pt idx="7">
                  <c:v>0.45090548611600162</c:v>
                </c:pt>
                <c:pt idx="8">
                  <c:v>1.3663997644987684</c:v>
                </c:pt>
                <c:pt idx="9">
                  <c:v>5.1491697844662516E-2</c:v>
                </c:pt>
                <c:pt idx="10">
                  <c:v>1.7791545805430343E-2</c:v>
                </c:pt>
                <c:pt idx="11">
                  <c:v>0.7400087618608675</c:v>
                </c:pt>
                <c:pt idx="12">
                  <c:v>5.2934687838232075E-2</c:v>
                </c:pt>
                <c:pt idx="13">
                  <c:v>3.5294261017706011E-2</c:v>
                </c:pt>
                <c:pt idx="14">
                  <c:v>6.1415779036649423E-2</c:v>
                </c:pt>
                <c:pt idx="15">
                  <c:v>26.248181042585085</c:v>
                </c:pt>
                <c:pt idx="16">
                  <c:v>2.7910442333333341E-2</c:v>
                </c:pt>
                <c:pt idx="17">
                  <c:v>16.590425163208991</c:v>
                </c:pt>
                <c:pt idx="18">
                  <c:v>36.878304476868074</c:v>
                </c:pt>
                <c:pt idx="19">
                  <c:v>3.5446101790146671E-2</c:v>
                </c:pt>
                <c:pt idx="20">
                  <c:v>1.3286049320644358</c:v>
                </c:pt>
                <c:pt idx="21">
                  <c:v>0.19189550791704937</c:v>
                </c:pt>
                <c:pt idx="22">
                  <c:v>19.585059378736094</c:v>
                </c:pt>
                <c:pt idx="23">
                  <c:v>5.1448442472523656E-2</c:v>
                </c:pt>
                <c:pt idx="24">
                  <c:v>0.32478976945904453</c:v>
                </c:pt>
                <c:pt idx="25">
                  <c:v>0.30612442472208024</c:v>
                </c:pt>
                <c:pt idx="26">
                  <c:v>2.2423340069397512E-2</c:v>
                </c:pt>
                <c:pt idx="27">
                  <c:v>7.4543738656017322E-2</c:v>
                </c:pt>
                <c:pt idx="28">
                  <c:v>0.28290099405026053</c:v>
                </c:pt>
                <c:pt idx="29">
                  <c:v>9.2813767158247351E-2</c:v>
                </c:pt>
                <c:pt idx="30">
                  <c:v>7.6483564227246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31-4368-8914-C595BF72B7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83867232"/>
        <c:axId val="883868320"/>
      </c:barChart>
      <c:catAx>
        <c:axId val="883867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3868320"/>
        <c:crosses val="autoZero"/>
        <c:auto val="1"/>
        <c:lblAlgn val="ctr"/>
        <c:lblOffset val="100"/>
        <c:noMultiLvlLbl val="0"/>
      </c:catAx>
      <c:valAx>
        <c:axId val="8838683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/>
                  <a:t>Relative</a:t>
                </a:r>
                <a:r>
                  <a:rPr lang="hu-HU" baseline="0"/>
                  <a:t> content</a:t>
                </a:r>
                <a:endParaRPr lang="hu-HU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3867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D56CE7-45B3-4FAB-A35A-4A8B159AF181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125FFE-C387-45C8-871E-69CC90045C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11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28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44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91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160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402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74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607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780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375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7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278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47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Csoportba foglalás 39"/>
          <p:cNvGrpSpPr/>
          <p:nvPr/>
        </p:nvGrpSpPr>
        <p:grpSpPr>
          <a:xfrm>
            <a:off x="390525" y="3465648"/>
            <a:ext cx="6287640" cy="412461"/>
            <a:chOff x="400050" y="3800801"/>
            <a:chExt cx="6287640" cy="412461"/>
          </a:xfrm>
        </p:grpSpPr>
        <p:grpSp>
          <p:nvGrpSpPr>
            <p:cNvPr id="12" name="Csoportba foglalás 11"/>
            <p:cNvGrpSpPr/>
            <p:nvPr/>
          </p:nvGrpSpPr>
          <p:grpSpPr>
            <a:xfrm>
              <a:off x="400050" y="3803563"/>
              <a:ext cx="2844800" cy="146137"/>
              <a:chOff x="400050" y="3682913"/>
              <a:chExt cx="2844800" cy="146137"/>
            </a:xfrm>
          </p:grpSpPr>
          <p:cxnSp>
            <p:nvCxnSpPr>
              <p:cNvPr id="6" name="Egyenes összekötő 5"/>
              <p:cNvCxnSpPr/>
              <p:nvPr/>
            </p:nvCxnSpPr>
            <p:spPr>
              <a:xfrm>
                <a:off x="406400" y="3682913"/>
                <a:ext cx="0" cy="14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Egyenes összekötő 7"/>
              <p:cNvCxnSpPr/>
              <p:nvPr/>
            </p:nvCxnSpPr>
            <p:spPr>
              <a:xfrm>
                <a:off x="400050" y="3829050"/>
                <a:ext cx="284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Egyenes összekötő 10"/>
              <p:cNvCxnSpPr/>
              <p:nvPr/>
            </p:nvCxnSpPr>
            <p:spPr>
              <a:xfrm>
                <a:off x="3244850" y="3682913"/>
                <a:ext cx="0" cy="14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4" name="Egyenes összekötő 13"/>
            <p:cNvCxnSpPr/>
            <p:nvPr/>
          </p:nvCxnSpPr>
          <p:spPr>
            <a:xfrm>
              <a:off x="3309719" y="3802388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Egyenes összekötő 14"/>
            <p:cNvCxnSpPr/>
            <p:nvPr/>
          </p:nvCxnSpPr>
          <p:spPr>
            <a:xfrm>
              <a:off x="3308089" y="3949708"/>
              <a:ext cx="75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Egyenes összekötő 15"/>
            <p:cNvCxnSpPr/>
            <p:nvPr/>
          </p:nvCxnSpPr>
          <p:spPr>
            <a:xfrm>
              <a:off x="4057041" y="3802388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Egyenes összekötő 16"/>
            <p:cNvCxnSpPr/>
            <p:nvPr/>
          </p:nvCxnSpPr>
          <p:spPr>
            <a:xfrm>
              <a:off x="4109471" y="3800801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Egyenes összekötő 17"/>
            <p:cNvCxnSpPr/>
            <p:nvPr/>
          </p:nvCxnSpPr>
          <p:spPr>
            <a:xfrm>
              <a:off x="4103208" y="3949564"/>
              <a:ext cx="50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Egyenes összekötő 18"/>
            <p:cNvCxnSpPr/>
            <p:nvPr/>
          </p:nvCxnSpPr>
          <p:spPr>
            <a:xfrm>
              <a:off x="4602619" y="3800801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Egyenes összekötő 25"/>
            <p:cNvCxnSpPr/>
            <p:nvPr/>
          </p:nvCxnSpPr>
          <p:spPr>
            <a:xfrm>
              <a:off x="4662703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Egyenes összekötő 26"/>
            <p:cNvCxnSpPr/>
            <p:nvPr/>
          </p:nvCxnSpPr>
          <p:spPr>
            <a:xfrm>
              <a:off x="4662703" y="3949564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Egyenes összekötő 27"/>
            <p:cNvCxnSpPr/>
            <p:nvPr/>
          </p:nvCxnSpPr>
          <p:spPr>
            <a:xfrm>
              <a:off x="5997810" y="3805564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Egyenes összekötő 29"/>
            <p:cNvCxnSpPr/>
            <p:nvPr/>
          </p:nvCxnSpPr>
          <p:spPr>
            <a:xfrm>
              <a:off x="6065615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Egyenes összekötő 30"/>
            <p:cNvCxnSpPr/>
            <p:nvPr/>
          </p:nvCxnSpPr>
          <p:spPr>
            <a:xfrm>
              <a:off x="6065615" y="3951652"/>
              <a:ext cx="54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Egyenes összekötő 31"/>
            <p:cNvCxnSpPr/>
            <p:nvPr/>
          </p:nvCxnSpPr>
          <p:spPr>
            <a:xfrm>
              <a:off x="6602604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Szövegdoboz 33"/>
            <p:cNvSpPr txBox="1"/>
            <p:nvPr/>
          </p:nvSpPr>
          <p:spPr>
            <a:xfrm>
              <a:off x="1246340" y="3951652"/>
              <a:ext cx="8771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Amino acids</a:t>
              </a:r>
            </a:p>
          </p:txBody>
        </p:sp>
        <p:sp>
          <p:nvSpPr>
            <p:cNvPr id="35" name="Szövegdoboz 34"/>
            <p:cNvSpPr txBox="1"/>
            <p:nvPr/>
          </p:nvSpPr>
          <p:spPr>
            <a:xfrm>
              <a:off x="3374989" y="3939546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Sugars</a:t>
              </a:r>
            </a:p>
          </p:txBody>
        </p:sp>
        <p:sp>
          <p:nvSpPr>
            <p:cNvPr id="36" name="Szövegdoboz 35"/>
            <p:cNvSpPr txBox="1"/>
            <p:nvPr/>
          </p:nvSpPr>
          <p:spPr>
            <a:xfrm>
              <a:off x="4014557" y="3939546"/>
              <a:ext cx="7312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Sugar alc.</a:t>
              </a:r>
            </a:p>
          </p:txBody>
        </p:sp>
        <p:sp>
          <p:nvSpPr>
            <p:cNvPr id="37" name="Szövegdoboz 36"/>
            <p:cNvSpPr txBox="1"/>
            <p:nvPr/>
          </p:nvSpPr>
          <p:spPr>
            <a:xfrm>
              <a:off x="4840043" y="3939546"/>
              <a:ext cx="9797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Organic acids</a:t>
              </a:r>
            </a:p>
          </p:txBody>
        </p:sp>
        <p:sp>
          <p:nvSpPr>
            <p:cNvPr id="38" name="Szövegdoboz 37"/>
            <p:cNvSpPr txBox="1"/>
            <p:nvPr/>
          </p:nvSpPr>
          <p:spPr>
            <a:xfrm>
              <a:off x="5975636" y="3930899"/>
              <a:ext cx="7120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Inorg. ac.</a:t>
              </a:r>
            </a:p>
          </p:txBody>
        </p:sp>
      </p:grpSp>
      <p:grpSp>
        <p:nvGrpSpPr>
          <p:cNvPr id="41" name="Csoportba foglalás 40"/>
          <p:cNvGrpSpPr/>
          <p:nvPr/>
        </p:nvGrpSpPr>
        <p:grpSpPr>
          <a:xfrm>
            <a:off x="419100" y="7571835"/>
            <a:ext cx="6287640" cy="412461"/>
            <a:chOff x="400050" y="3800801"/>
            <a:chExt cx="6287640" cy="412461"/>
          </a:xfrm>
        </p:grpSpPr>
        <p:grpSp>
          <p:nvGrpSpPr>
            <p:cNvPr id="42" name="Csoportba foglalás 41"/>
            <p:cNvGrpSpPr/>
            <p:nvPr/>
          </p:nvGrpSpPr>
          <p:grpSpPr>
            <a:xfrm>
              <a:off x="400050" y="3803563"/>
              <a:ext cx="2844800" cy="146137"/>
              <a:chOff x="400050" y="3682913"/>
              <a:chExt cx="2844800" cy="146137"/>
            </a:xfrm>
          </p:grpSpPr>
          <p:cxnSp>
            <p:nvCxnSpPr>
              <p:cNvPr id="60" name="Egyenes összekötő 59"/>
              <p:cNvCxnSpPr/>
              <p:nvPr/>
            </p:nvCxnSpPr>
            <p:spPr>
              <a:xfrm>
                <a:off x="406400" y="3682913"/>
                <a:ext cx="0" cy="14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Egyenes összekötő 60"/>
              <p:cNvCxnSpPr/>
              <p:nvPr/>
            </p:nvCxnSpPr>
            <p:spPr>
              <a:xfrm>
                <a:off x="400050" y="3829050"/>
                <a:ext cx="284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Egyenes összekötő 61"/>
              <p:cNvCxnSpPr/>
              <p:nvPr/>
            </p:nvCxnSpPr>
            <p:spPr>
              <a:xfrm>
                <a:off x="3244850" y="3682913"/>
                <a:ext cx="0" cy="14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3" name="Egyenes összekötő 42"/>
            <p:cNvCxnSpPr/>
            <p:nvPr/>
          </p:nvCxnSpPr>
          <p:spPr>
            <a:xfrm>
              <a:off x="3309719" y="3802388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Egyenes összekötő 43"/>
            <p:cNvCxnSpPr/>
            <p:nvPr/>
          </p:nvCxnSpPr>
          <p:spPr>
            <a:xfrm>
              <a:off x="3308089" y="3949708"/>
              <a:ext cx="75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Egyenes összekötő 44"/>
            <p:cNvCxnSpPr/>
            <p:nvPr/>
          </p:nvCxnSpPr>
          <p:spPr>
            <a:xfrm>
              <a:off x="4057041" y="3802388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Egyenes összekötő 45"/>
            <p:cNvCxnSpPr/>
            <p:nvPr/>
          </p:nvCxnSpPr>
          <p:spPr>
            <a:xfrm>
              <a:off x="4109471" y="3800801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Egyenes összekötő 46"/>
            <p:cNvCxnSpPr/>
            <p:nvPr/>
          </p:nvCxnSpPr>
          <p:spPr>
            <a:xfrm>
              <a:off x="4103208" y="3949564"/>
              <a:ext cx="50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Egyenes összekötő 47"/>
            <p:cNvCxnSpPr/>
            <p:nvPr/>
          </p:nvCxnSpPr>
          <p:spPr>
            <a:xfrm>
              <a:off x="4602619" y="3800801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Egyenes összekötő 48"/>
            <p:cNvCxnSpPr/>
            <p:nvPr/>
          </p:nvCxnSpPr>
          <p:spPr>
            <a:xfrm>
              <a:off x="4662703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Egyenes összekötő 49"/>
            <p:cNvCxnSpPr/>
            <p:nvPr/>
          </p:nvCxnSpPr>
          <p:spPr>
            <a:xfrm>
              <a:off x="4662703" y="3949564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Egyenes összekötő 50"/>
            <p:cNvCxnSpPr/>
            <p:nvPr/>
          </p:nvCxnSpPr>
          <p:spPr>
            <a:xfrm>
              <a:off x="5997810" y="3805564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Egyenes összekötő 51"/>
            <p:cNvCxnSpPr/>
            <p:nvPr/>
          </p:nvCxnSpPr>
          <p:spPr>
            <a:xfrm>
              <a:off x="6065615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Egyenes összekötő 52"/>
            <p:cNvCxnSpPr/>
            <p:nvPr/>
          </p:nvCxnSpPr>
          <p:spPr>
            <a:xfrm>
              <a:off x="6065615" y="3951652"/>
              <a:ext cx="54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Egyenes összekötő 53"/>
            <p:cNvCxnSpPr/>
            <p:nvPr/>
          </p:nvCxnSpPr>
          <p:spPr>
            <a:xfrm>
              <a:off x="6602604" y="3802889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Szövegdoboz 54"/>
            <p:cNvSpPr txBox="1"/>
            <p:nvPr/>
          </p:nvSpPr>
          <p:spPr>
            <a:xfrm>
              <a:off x="1246340" y="3951652"/>
              <a:ext cx="8771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Amino acids</a:t>
              </a:r>
            </a:p>
          </p:txBody>
        </p:sp>
        <p:sp>
          <p:nvSpPr>
            <p:cNvPr id="56" name="Szövegdoboz 55"/>
            <p:cNvSpPr txBox="1"/>
            <p:nvPr/>
          </p:nvSpPr>
          <p:spPr>
            <a:xfrm>
              <a:off x="3374989" y="3939546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Sugars</a:t>
              </a:r>
            </a:p>
          </p:txBody>
        </p:sp>
        <p:sp>
          <p:nvSpPr>
            <p:cNvPr id="57" name="Szövegdoboz 56"/>
            <p:cNvSpPr txBox="1"/>
            <p:nvPr/>
          </p:nvSpPr>
          <p:spPr>
            <a:xfrm>
              <a:off x="4014557" y="3939546"/>
              <a:ext cx="7312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Sugar alc.</a:t>
              </a:r>
            </a:p>
          </p:txBody>
        </p:sp>
        <p:sp>
          <p:nvSpPr>
            <p:cNvPr id="58" name="Szövegdoboz 57"/>
            <p:cNvSpPr txBox="1"/>
            <p:nvPr/>
          </p:nvSpPr>
          <p:spPr>
            <a:xfrm>
              <a:off x="4840043" y="3939546"/>
              <a:ext cx="9797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Organic acids</a:t>
              </a:r>
            </a:p>
          </p:txBody>
        </p:sp>
        <p:sp>
          <p:nvSpPr>
            <p:cNvPr id="59" name="Szövegdoboz 58"/>
            <p:cNvSpPr txBox="1"/>
            <p:nvPr/>
          </p:nvSpPr>
          <p:spPr>
            <a:xfrm>
              <a:off x="5975636" y="3930899"/>
              <a:ext cx="7120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100" noProof="1"/>
                <a:t>Inorg. ac.</a:t>
              </a:r>
            </a:p>
          </p:txBody>
        </p:sp>
      </p:grpSp>
      <p:sp>
        <p:nvSpPr>
          <p:cNvPr id="3" name="Szövegdoboz 2"/>
          <p:cNvSpPr txBox="1"/>
          <p:nvPr/>
        </p:nvSpPr>
        <p:spPr>
          <a:xfrm>
            <a:off x="344110" y="8100200"/>
            <a:ext cx="62775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3 Fig. Metabolite composition of leaves. 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e relative data shown on the y axis are derived from a comparison of the peak sizes of the samples and an internal standard, ribitol.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The m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eans were obtained from 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two consecutive experiments from 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three-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biological repeats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(S1 Table). The s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tandard deviations are indicated by error bars.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hu-HU" sz="1200" b="1" noProof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5" name="Csoportba foglalás 64"/>
          <p:cNvGrpSpPr/>
          <p:nvPr/>
        </p:nvGrpSpPr>
        <p:grpSpPr>
          <a:xfrm>
            <a:off x="0" y="0"/>
            <a:ext cx="6858000" cy="3933825"/>
            <a:chOff x="0" y="0"/>
            <a:chExt cx="6858000" cy="3933825"/>
          </a:xfrm>
        </p:grpSpPr>
        <p:graphicFrame>
          <p:nvGraphicFramePr>
            <p:cNvPr id="66" name="Diagram 65"/>
            <p:cNvGraphicFramePr>
              <a:graphicFrameLocks/>
            </p:cNvGraphicFramePr>
            <p:nvPr/>
          </p:nvGraphicFramePr>
          <p:xfrm>
            <a:off x="0" y="0"/>
            <a:ext cx="6858000" cy="34253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3" name="Téglalap 62"/>
            <p:cNvSpPr/>
            <p:nvPr/>
          </p:nvSpPr>
          <p:spPr>
            <a:xfrm>
              <a:off x="123826" y="114300"/>
              <a:ext cx="6591300" cy="38195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</p:grpSp>
      <p:grpSp>
        <p:nvGrpSpPr>
          <p:cNvPr id="68" name="Csoportba foglalás 67"/>
          <p:cNvGrpSpPr/>
          <p:nvPr/>
        </p:nvGrpSpPr>
        <p:grpSpPr>
          <a:xfrm>
            <a:off x="0" y="4171950"/>
            <a:ext cx="6858000" cy="3819525"/>
            <a:chOff x="0" y="4171950"/>
            <a:chExt cx="6858000" cy="3819525"/>
          </a:xfrm>
        </p:grpSpPr>
        <p:graphicFrame>
          <p:nvGraphicFramePr>
            <p:cNvPr id="67" name="Diagram 66"/>
            <p:cNvGraphicFramePr>
              <a:graphicFrameLocks/>
            </p:cNvGraphicFramePr>
            <p:nvPr/>
          </p:nvGraphicFramePr>
          <p:xfrm>
            <a:off x="0" y="4191000"/>
            <a:ext cx="6858000" cy="32575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4" name="Téglalap 63"/>
            <p:cNvSpPr/>
            <p:nvPr/>
          </p:nvSpPr>
          <p:spPr>
            <a:xfrm>
              <a:off x="133351" y="4171950"/>
              <a:ext cx="6591300" cy="38195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</p:grpSp>
    </p:spTree>
    <p:extLst>
      <p:ext uri="{BB962C8B-B14F-4D97-AF65-F5344CB8AC3E}">
        <p14:creationId xmlns:p14="http://schemas.microsoft.com/office/powerpoint/2010/main" val="361525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2</TotalTime>
  <Words>96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Home</dc:creator>
  <cp:lastModifiedBy>sathiya vikram</cp:lastModifiedBy>
  <cp:revision>94</cp:revision>
  <dcterms:created xsi:type="dcterms:W3CDTF">2020-04-29T23:07:35Z</dcterms:created>
  <dcterms:modified xsi:type="dcterms:W3CDTF">2021-04-20T04:23:46Z</dcterms:modified>
</cp:coreProperties>
</file>